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78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  <p:embeddedFont>
      <p:font typeface="Helvetica" pitchFamily="2" charset="0"/>
      <p:regular r:id="rId10"/>
      <p:bold r:id="rId11"/>
      <p:italic r:id="rId12"/>
      <p:boldItalic r:id="rId13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>
        <p:scale>
          <a:sx n="125" d="100"/>
          <a:sy n="125" d="100"/>
        </p:scale>
        <p:origin x="744" y="-4092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1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presProps" Target="presProps.xml"/><Relationship Id="rId10" Type="http://schemas.openxmlformats.org/officeDocument/2006/relationships/font" Target="fonts/font7.fntdata"/><Relationship Id="rId19" Type="http://schemas.microsoft.com/office/2018/10/relationships/authors" Target="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9898112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1908" y="8168397"/>
            <a:ext cx="57541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| Depiction of expanded and overexpressed reactions in Atacama plant species. a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the expanded reactions in the Atacama species (Pearson correlation, Ward algorithm). 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ribution of the highly expressed reactions in the Atacama species (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e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the number of top expressed gene isoforms per reaction) (Pearson correlation, Ward algorithm).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7"/>
            <a:ext cx="5760000" cy="7569734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3B2168A-FB56-624F-189F-861ACA8FD00E}"/>
              </a:ext>
            </a:extLst>
          </p:cNvPr>
          <p:cNvSpPr txBox="1"/>
          <p:nvPr/>
        </p:nvSpPr>
        <p:spPr>
          <a:xfrm>
            <a:off x="510509" y="50663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8B6D6D9E-5EA2-7979-E0B1-0C302983CC04}"/>
              </a:ext>
            </a:extLst>
          </p:cNvPr>
          <p:cNvSpPr txBox="1"/>
          <p:nvPr/>
        </p:nvSpPr>
        <p:spPr>
          <a:xfrm>
            <a:off x="505700" y="423680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b</a:t>
            </a:r>
          </a:p>
        </p:txBody>
      </p:sp>
      <p:pic>
        <p:nvPicPr>
          <p:cNvPr id="5" name="Graphique 4">
            <a:extLst>
              <a:ext uri="{FF2B5EF4-FFF2-40B4-BE49-F238E27FC236}">
                <a16:creationId xmlns:a16="http://schemas.microsoft.com/office/drawing/2014/main" id="{BCF099DB-BBC8-9A8F-C5A5-D9CFF324126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25550" y="4513806"/>
            <a:ext cx="5400000" cy="3496767"/>
          </a:xfrm>
          <a:prstGeom prst="rect">
            <a:avLst/>
          </a:prstGeom>
        </p:spPr>
      </p:pic>
      <p:pic>
        <p:nvPicPr>
          <p:cNvPr id="7" name="Graphique 6">
            <a:extLst>
              <a:ext uri="{FF2B5EF4-FFF2-40B4-BE49-F238E27FC236}">
                <a16:creationId xmlns:a16="http://schemas.microsoft.com/office/drawing/2014/main" id="{E8A94ED8-BF08-23A3-EC8E-8672C1DFC88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725550" y="713873"/>
            <a:ext cx="5400000" cy="3592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505293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72</Words>
  <Application>Microsoft Office PowerPoint</Application>
  <PresentationFormat>Format A4 (210 x 297 mm)</PresentationFormat>
  <Paragraphs>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Calibri</vt:lpstr>
      <vt:lpstr>Helvetica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1:35Z</dcterms:modified>
</cp:coreProperties>
</file>